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charts/style2.xml" ContentType="application/vnd.ms-office.chartstyl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olors4.xml" ContentType="application/vnd.ms-office.chartcolorstyle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olors2.xml" ContentType="application/vnd.ms-office.chartcolorstyle+xml"/>
  <Override PartName="/ppt/charts/colors3.xml" ContentType="application/vnd.ms-office.chartcolorstyl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3.xml" ContentType="application/vnd.ms-office.chartstyle+xml"/>
  <Override PartName="/ppt/charts/style4.xml" ContentType="application/vnd.ms-office.chartstyle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drawings/drawing1.xml" ContentType="application/vnd.openxmlformats-officedocument.drawingml.chartshapes+xml"/>
  <Default Extension="emf" ContentType="image/x-emf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284" autoAdjust="0"/>
    <p:restoredTop sz="94660"/>
  </p:normalViewPr>
  <p:slideViewPr>
    <p:cSldViewPr snapToGrid="0">
      <p:cViewPr varScale="1">
        <p:scale>
          <a:sx n="81" d="100"/>
          <a:sy n="81" d="100"/>
        </p:scale>
        <p:origin x="369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hysiology%20new%20May%202016\DFPL\chlorophyll%20correct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hysiology%20new%20May%202016\DFPL\growth%20curv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hysiology%20new%20May%202016\DFPL\chlorophyll%20correcte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hysiology%20new%20May%202016\DFPL\growth%20curve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2:$N$12</c:f>
                <c:numCache>
                  <c:formatCode>General</c:formatCode>
                  <c:ptCount val="11"/>
                  <c:pt idx="0">
                    <c:v>0.73018220601537642</c:v>
                  </c:pt>
                  <c:pt idx="1">
                    <c:v>1.0965747005313231</c:v>
                  </c:pt>
                  <c:pt idx="3">
                    <c:v>1.4366271342744035</c:v>
                  </c:pt>
                  <c:pt idx="4">
                    <c:v>0.50389880058853886</c:v>
                  </c:pt>
                  <c:pt idx="6">
                    <c:v>1.052455097574529</c:v>
                  </c:pt>
                  <c:pt idx="7">
                    <c:v>1.5410599481837068</c:v>
                  </c:pt>
                  <c:pt idx="9">
                    <c:v>2.1203860736811384</c:v>
                  </c:pt>
                  <c:pt idx="10">
                    <c:v>1.5482135906559122</c:v>
                  </c:pt>
                </c:numCache>
              </c:numRef>
            </c:plus>
            <c:minus>
              <c:numRef>
                <c:f>Sheet2!$N$2:$N$12</c:f>
                <c:numCache>
                  <c:formatCode>General</c:formatCode>
                  <c:ptCount val="11"/>
                  <c:pt idx="0">
                    <c:v>0.73018220601537642</c:v>
                  </c:pt>
                  <c:pt idx="1">
                    <c:v>1.0965747005313231</c:v>
                  </c:pt>
                  <c:pt idx="3">
                    <c:v>1.4366271342744035</c:v>
                  </c:pt>
                  <c:pt idx="4">
                    <c:v>0.50389880058853886</c:v>
                  </c:pt>
                  <c:pt idx="6">
                    <c:v>1.052455097574529</c:v>
                  </c:pt>
                  <c:pt idx="7">
                    <c:v>1.5410599481837068</c:v>
                  </c:pt>
                  <c:pt idx="9">
                    <c:v>2.1203860736811384</c:v>
                  </c:pt>
                  <c:pt idx="10">
                    <c:v>1.54821359065591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L$2:$L$12</c:f>
              <c:strCache>
                <c:ptCount val="11"/>
                <c:pt idx="0">
                  <c:v>Abs control</c:v>
                </c:pt>
                <c:pt idx="1">
                  <c:v>Rs only</c:v>
                </c:pt>
                <c:pt idx="3">
                  <c:v>FC-60</c:v>
                </c:pt>
                <c:pt idx="4">
                  <c:v>FC-60 + Rs</c:v>
                </c:pt>
                <c:pt idx="6">
                  <c:v>FC-40 </c:v>
                </c:pt>
                <c:pt idx="7">
                  <c:v>FC-40 + Rs</c:v>
                </c:pt>
                <c:pt idx="9">
                  <c:v>FC-20</c:v>
                </c:pt>
                <c:pt idx="10">
                  <c:v>FC-20 + Rs</c:v>
                </c:pt>
              </c:strCache>
            </c:strRef>
          </c:cat>
          <c:val>
            <c:numRef>
              <c:f>Sheet2!$M$2:$M$12</c:f>
              <c:numCache>
                <c:formatCode>General</c:formatCode>
                <c:ptCount val="11"/>
                <c:pt idx="0">
                  <c:v>17.141183333333334</c:v>
                </c:pt>
                <c:pt idx="1">
                  <c:v>7.0192705314009674</c:v>
                </c:pt>
                <c:pt idx="3">
                  <c:v>13.65790196078431</c:v>
                </c:pt>
                <c:pt idx="4">
                  <c:v>2.7608777777777775</c:v>
                </c:pt>
                <c:pt idx="6">
                  <c:v>17.462588235294113</c:v>
                </c:pt>
                <c:pt idx="7">
                  <c:v>15.466851190476191</c:v>
                </c:pt>
                <c:pt idx="9">
                  <c:v>19.151986486486486</c:v>
                </c:pt>
                <c:pt idx="10">
                  <c:v>14.665091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9"/>
        <c:overlap val="-27"/>
        <c:axId val="728989568"/>
        <c:axId val="728977056"/>
      </c:barChart>
      <c:catAx>
        <c:axId val="72898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28977056"/>
        <c:crosses val="autoZero"/>
        <c:auto val="1"/>
        <c:lblAlgn val="ctr"/>
        <c:lblOffset val="100"/>
        <c:noMultiLvlLbl val="0"/>
      </c:catAx>
      <c:valAx>
        <c:axId val="7289770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dirty="0" smtClean="0">
                    <a:solidFill>
                      <a:schemeClr val="tx1"/>
                    </a:solidFill>
                  </a:rPr>
                  <a:t>Total chlorophyll/mg (dry </a:t>
                </a:r>
                <a:r>
                  <a:rPr lang="en-US" sz="900" dirty="0" err="1" smtClean="0">
                    <a:solidFill>
                      <a:schemeClr val="tx1"/>
                    </a:solidFill>
                  </a:rPr>
                  <a:t>wt</a:t>
                </a:r>
                <a:r>
                  <a:rPr lang="en-US" sz="900" dirty="0" smtClean="0">
                    <a:solidFill>
                      <a:schemeClr val="tx1"/>
                    </a:solidFill>
                  </a:rPr>
                  <a:t>)</a:t>
                </a:r>
                <a:endParaRPr lang="en-US" sz="9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28989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31353893263342"/>
          <c:y val="5.0925925925925923E-2"/>
          <c:w val="0.82004422298775148"/>
          <c:h val="0.735771361913094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6!$A$7</c:f>
              <c:strCache>
                <c:ptCount val="1"/>
                <c:pt idx="0">
                  <c:v>Rs onl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G$7:$I$7</c:f>
                <c:numCache>
                  <c:formatCode>General</c:formatCode>
                  <c:ptCount val="3"/>
                  <c:pt idx="0">
                    <c:v>0.11149568115397465</c:v>
                  </c:pt>
                  <c:pt idx="1">
                    <c:v>0.25109696696040973</c:v>
                  </c:pt>
                  <c:pt idx="2">
                    <c:v>0.57994163948161792</c:v>
                  </c:pt>
                </c:numCache>
              </c:numRef>
            </c:plus>
            <c:minus>
              <c:numRef>
                <c:f>Sheet6!$G$7:$I$7</c:f>
                <c:numCache>
                  <c:formatCode>General</c:formatCode>
                  <c:ptCount val="3"/>
                  <c:pt idx="0">
                    <c:v>0.11149568115397465</c:v>
                  </c:pt>
                  <c:pt idx="1">
                    <c:v>0.25109696696040973</c:v>
                  </c:pt>
                  <c:pt idx="2">
                    <c:v>0.579941639481617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6:$D$6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6!$B$7:$D$7</c:f>
              <c:numCache>
                <c:formatCode>General</c:formatCode>
                <c:ptCount val="3"/>
                <c:pt idx="0">
                  <c:v>4.2661408064291093</c:v>
                </c:pt>
                <c:pt idx="1">
                  <c:v>4.7614072204933526</c:v>
                </c:pt>
                <c:pt idx="2">
                  <c:v>5.4417419916964738</c:v>
                </c:pt>
              </c:numCache>
            </c:numRef>
          </c:val>
        </c:ser>
        <c:ser>
          <c:idx val="1"/>
          <c:order val="1"/>
          <c:tx>
            <c:strRef>
              <c:f>Sheet6!$A$8</c:f>
              <c:strCache>
                <c:ptCount val="1"/>
                <c:pt idx="0">
                  <c:v>FC-60 + R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G$8:$I$8</c:f>
                <c:numCache>
                  <c:formatCode>General</c:formatCode>
                  <c:ptCount val="3"/>
                  <c:pt idx="0">
                    <c:v>0.22940007738611784</c:v>
                  </c:pt>
                  <c:pt idx="1">
                    <c:v>0.17666654998728423</c:v>
                  </c:pt>
                  <c:pt idx="2">
                    <c:v>0.36212996741692605</c:v>
                  </c:pt>
                </c:numCache>
              </c:numRef>
            </c:plus>
            <c:minus>
              <c:numRef>
                <c:f>Sheet6!$G$8:$I$8</c:f>
                <c:numCache>
                  <c:formatCode>General</c:formatCode>
                  <c:ptCount val="3"/>
                  <c:pt idx="0">
                    <c:v>0.22940007738611784</c:v>
                  </c:pt>
                  <c:pt idx="1">
                    <c:v>0.17666654998728423</c:v>
                  </c:pt>
                  <c:pt idx="2">
                    <c:v>0.362129967416926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6:$D$6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6!$B$8:$D$8</c:f>
              <c:numCache>
                <c:formatCode>General</c:formatCode>
                <c:ptCount val="3"/>
                <c:pt idx="0">
                  <c:v>4.4391772790035269</c:v>
                </c:pt>
                <c:pt idx="1">
                  <c:v>5.4209863955287405</c:v>
                </c:pt>
                <c:pt idx="2">
                  <c:v>6.0316759963412743</c:v>
                </c:pt>
              </c:numCache>
            </c:numRef>
          </c:val>
        </c:ser>
        <c:ser>
          <c:idx val="2"/>
          <c:order val="2"/>
          <c:tx>
            <c:strRef>
              <c:f>Sheet6!$A$9</c:f>
              <c:strCache>
                <c:ptCount val="1"/>
                <c:pt idx="0">
                  <c:v>FC-40 + R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G$9:$I$9</c:f>
                <c:numCache>
                  <c:formatCode>General</c:formatCode>
                  <c:ptCount val="3"/>
                  <c:pt idx="0">
                    <c:v>0.21158805597873218</c:v>
                  </c:pt>
                  <c:pt idx="1">
                    <c:v>0.18914261521827033</c:v>
                  </c:pt>
                  <c:pt idx="2">
                    <c:v>0.40133477907440035</c:v>
                  </c:pt>
                </c:numCache>
              </c:numRef>
            </c:plus>
            <c:minus>
              <c:numRef>
                <c:f>Sheet6!$G$9:$I$9</c:f>
                <c:numCache>
                  <c:formatCode>General</c:formatCode>
                  <c:ptCount val="3"/>
                  <c:pt idx="0">
                    <c:v>0.21158805597873218</c:v>
                  </c:pt>
                  <c:pt idx="1">
                    <c:v>0.18914261521827033</c:v>
                  </c:pt>
                  <c:pt idx="2">
                    <c:v>0.40133477907440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6:$D$6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6!$B$9:$D$9</c:f>
              <c:numCache>
                <c:formatCode>General</c:formatCode>
                <c:ptCount val="3"/>
                <c:pt idx="0">
                  <c:v>3.5964797863215767</c:v>
                </c:pt>
                <c:pt idx="1">
                  <c:v>4.4142425846019409</c:v>
                </c:pt>
                <c:pt idx="2">
                  <c:v>5.0369486412714508</c:v>
                </c:pt>
              </c:numCache>
            </c:numRef>
          </c:val>
        </c:ser>
        <c:ser>
          <c:idx val="3"/>
          <c:order val="3"/>
          <c:tx>
            <c:strRef>
              <c:f>Sheet6!$A$10</c:f>
              <c:strCache>
                <c:ptCount val="1"/>
                <c:pt idx="0">
                  <c:v>FC-20 + R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G$10:$I$10</c:f>
                <c:numCache>
                  <c:formatCode>General</c:formatCode>
                  <c:ptCount val="3"/>
                  <c:pt idx="0">
                    <c:v>5.11755732316692E-2</c:v>
                  </c:pt>
                  <c:pt idx="1">
                    <c:v>0.34728525333387766</c:v>
                  </c:pt>
                  <c:pt idx="2">
                    <c:v>0.15201765960784477</c:v>
                  </c:pt>
                </c:numCache>
              </c:numRef>
            </c:plus>
            <c:minus>
              <c:numRef>
                <c:f>Sheet6!$G$10:$I$10</c:f>
                <c:numCache>
                  <c:formatCode>General</c:formatCode>
                  <c:ptCount val="3"/>
                  <c:pt idx="0">
                    <c:v>5.11755732316692E-2</c:v>
                  </c:pt>
                  <c:pt idx="1">
                    <c:v>0.34728525333387766</c:v>
                  </c:pt>
                  <c:pt idx="2">
                    <c:v>0.152017659607844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6:$D$6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6!$B$10:$D$10</c:f>
              <c:numCache>
                <c:formatCode>General</c:formatCode>
                <c:ptCount val="3"/>
                <c:pt idx="0">
                  <c:v>3.7850188038668904</c:v>
                </c:pt>
                <c:pt idx="1">
                  <c:v>4.7133318686646257</c:v>
                </c:pt>
                <c:pt idx="2">
                  <c:v>4.5728262387739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28691504"/>
        <c:axId val="728689872"/>
      </c:barChart>
      <c:catAx>
        <c:axId val="728691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28689872"/>
        <c:crosses val="autoZero"/>
        <c:auto val="1"/>
        <c:lblAlgn val="ctr"/>
        <c:lblOffset val="100"/>
        <c:noMultiLvlLbl val="0"/>
      </c:catAx>
      <c:valAx>
        <c:axId val="7286898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 i="1" dirty="0" smtClean="0">
                    <a:solidFill>
                      <a:schemeClr val="tx1"/>
                    </a:solidFill>
                    <a:effectLst/>
                  </a:rPr>
                  <a:t>In-planta</a:t>
                </a:r>
                <a:r>
                  <a:rPr lang="en-US" sz="900" b="1" dirty="0" smtClean="0">
                    <a:solidFill>
                      <a:schemeClr val="tx1"/>
                    </a:solidFill>
                    <a:effectLst/>
                  </a:rPr>
                  <a:t> bacterial number </a:t>
                </a:r>
                <a:endParaRPr lang="en-US" sz="900" dirty="0" smtClean="0">
                  <a:solidFill>
                    <a:schemeClr val="tx1"/>
                  </a:solidFill>
                  <a:effectLst/>
                </a:endParaRPr>
              </a:p>
              <a:p>
                <a:pPr>
                  <a:defRPr sz="900"/>
                </a:pPr>
                <a:r>
                  <a:rPr lang="en-US" sz="900" b="1" dirty="0" smtClean="0">
                    <a:solidFill>
                      <a:schemeClr val="tx1"/>
                    </a:solidFill>
                    <a:effectLst/>
                  </a:rPr>
                  <a:t>   Log</a:t>
                </a:r>
                <a:r>
                  <a:rPr lang="en-US" sz="900" b="1" baseline="-25000" dirty="0" smtClean="0">
                    <a:solidFill>
                      <a:schemeClr val="tx1"/>
                    </a:solidFill>
                    <a:effectLst/>
                  </a:rPr>
                  <a:t>10 </a:t>
                </a:r>
                <a:r>
                  <a:rPr lang="en-US" sz="900" b="1" dirty="0" smtClean="0">
                    <a:solidFill>
                      <a:schemeClr val="tx1"/>
                    </a:solidFill>
                    <a:effectLst/>
                  </a:rPr>
                  <a:t>(CFU /mg</a:t>
                </a:r>
                <a:r>
                  <a:rPr lang="en-US" sz="900" b="1" baseline="-25000" dirty="0" smtClean="0">
                    <a:solidFill>
                      <a:schemeClr val="tx1"/>
                    </a:solidFill>
                    <a:effectLst/>
                  </a:rPr>
                  <a:t> </a:t>
                </a:r>
                <a:r>
                  <a:rPr lang="en-US" sz="900" b="1" dirty="0" smtClean="0">
                    <a:solidFill>
                      <a:schemeClr val="tx1"/>
                    </a:solidFill>
                    <a:effectLst/>
                  </a:rPr>
                  <a:t>)</a:t>
                </a:r>
                <a:r>
                  <a:rPr lang="en-US" sz="900" b="1" baseline="0" dirty="0" smtClean="0">
                    <a:solidFill>
                      <a:schemeClr val="tx1"/>
                    </a:solidFill>
                    <a:effectLst/>
                  </a:rPr>
                  <a:t> </a:t>
                </a:r>
                <a:endParaRPr lang="en-US" sz="900" dirty="0" smtClean="0">
                  <a:solidFill>
                    <a:schemeClr val="tx1"/>
                  </a:solidFill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28691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H$2:$H$12</c:f>
                <c:numCache>
                  <c:formatCode>General</c:formatCode>
                  <c:ptCount val="11"/>
                  <c:pt idx="0">
                    <c:v>0.73018220601537642</c:v>
                  </c:pt>
                  <c:pt idx="1">
                    <c:v>2.8669843046072958</c:v>
                  </c:pt>
                  <c:pt idx="3">
                    <c:v>1.4366271342744035</c:v>
                  </c:pt>
                  <c:pt idx="4">
                    <c:v>1.9976757881871323</c:v>
                  </c:pt>
                  <c:pt idx="6">
                    <c:v>1.052455097574529</c:v>
                  </c:pt>
                  <c:pt idx="7">
                    <c:v>3.9245249725702833</c:v>
                  </c:pt>
                  <c:pt idx="9">
                    <c:v>2.1203860736811384</c:v>
                  </c:pt>
                  <c:pt idx="10">
                    <c:v>1.8347011530707054</c:v>
                  </c:pt>
                </c:numCache>
              </c:numRef>
            </c:plus>
            <c:minus>
              <c:numRef>
                <c:f>Sheet2!$H$2:$H$12</c:f>
                <c:numCache>
                  <c:formatCode>General</c:formatCode>
                  <c:ptCount val="11"/>
                  <c:pt idx="0">
                    <c:v>0.73018220601537642</c:v>
                  </c:pt>
                  <c:pt idx="1">
                    <c:v>2.8669843046072958</c:v>
                  </c:pt>
                  <c:pt idx="3">
                    <c:v>1.4366271342744035</c:v>
                  </c:pt>
                  <c:pt idx="4">
                    <c:v>1.9976757881871323</c:v>
                  </c:pt>
                  <c:pt idx="6">
                    <c:v>1.052455097574529</c:v>
                  </c:pt>
                  <c:pt idx="7">
                    <c:v>3.9245249725702833</c:v>
                  </c:pt>
                  <c:pt idx="9">
                    <c:v>2.1203860736811384</c:v>
                  </c:pt>
                  <c:pt idx="10">
                    <c:v>1.83470115307070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F$2:$F$12</c:f>
              <c:strCache>
                <c:ptCount val="11"/>
                <c:pt idx="0">
                  <c:v>Abs control</c:v>
                </c:pt>
                <c:pt idx="1">
                  <c:v>Psp only</c:v>
                </c:pt>
                <c:pt idx="3">
                  <c:v>FC-60</c:v>
                </c:pt>
                <c:pt idx="4">
                  <c:v>FC-60 + Psp</c:v>
                </c:pt>
                <c:pt idx="6">
                  <c:v>FC-40 </c:v>
                </c:pt>
                <c:pt idx="7">
                  <c:v>FC-40 + Psp</c:v>
                </c:pt>
                <c:pt idx="9">
                  <c:v>FC-20</c:v>
                </c:pt>
                <c:pt idx="10">
                  <c:v>FC-20 + Psp</c:v>
                </c:pt>
              </c:strCache>
            </c:strRef>
          </c:cat>
          <c:val>
            <c:numRef>
              <c:f>Sheet2!$G$2:$G$12</c:f>
              <c:numCache>
                <c:formatCode>General</c:formatCode>
                <c:ptCount val="11"/>
                <c:pt idx="0">
                  <c:v>17.141183333333334</c:v>
                </c:pt>
                <c:pt idx="1">
                  <c:v>11.856187499999999</c:v>
                </c:pt>
                <c:pt idx="3">
                  <c:v>13.65790196078431</c:v>
                </c:pt>
                <c:pt idx="4">
                  <c:v>9.9610576923076923</c:v>
                </c:pt>
                <c:pt idx="6">
                  <c:v>17.462588235294113</c:v>
                </c:pt>
                <c:pt idx="7">
                  <c:v>9.944112903225804</c:v>
                </c:pt>
                <c:pt idx="9">
                  <c:v>19.151986486486486</c:v>
                </c:pt>
                <c:pt idx="10">
                  <c:v>12.0360555555555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9"/>
        <c:overlap val="-27"/>
        <c:axId val="973072320"/>
        <c:axId val="973073952"/>
      </c:barChart>
      <c:catAx>
        <c:axId val="973072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73073952"/>
        <c:crosses val="autoZero"/>
        <c:auto val="1"/>
        <c:lblAlgn val="ctr"/>
        <c:lblOffset val="100"/>
        <c:noMultiLvlLbl val="0"/>
      </c:catAx>
      <c:valAx>
        <c:axId val="9730739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dirty="0" smtClean="0">
                    <a:solidFill>
                      <a:schemeClr val="tx1"/>
                    </a:solidFill>
                  </a:rPr>
                  <a:t>Total</a:t>
                </a:r>
                <a:r>
                  <a:rPr lang="en-US" sz="900" baseline="0" dirty="0" smtClean="0">
                    <a:solidFill>
                      <a:schemeClr val="tx1"/>
                    </a:solidFill>
                  </a:rPr>
                  <a:t> chlorophyll/mg (dry </a:t>
                </a:r>
                <a:r>
                  <a:rPr lang="en-US" sz="900" baseline="0" dirty="0" err="1" smtClean="0">
                    <a:solidFill>
                      <a:schemeClr val="tx1"/>
                    </a:solidFill>
                  </a:rPr>
                  <a:t>wt</a:t>
                </a:r>
                <a:r>
                  <a:rPr lang="en-US" sz="900" baseline="0" dirty="0" smtClean="0">
                    <a:solidFill>
                      <a:schemeClr val="tx1"/>
                    </a:solidFill>
                  </a:rPr>
                  <a:t>)</a:t>
                </a:r>
                <a:endParaRPr lang="en-US" sz="9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73072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033437226596676"/>
          <c:y val="6.2613843351548265E-2"/>
          <c:w val="0.78192257217847771"/>
          <c:h val="0.633004442579923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A$12</c:f>
              <c:strCache>
                <c:ptCount val="1"/>
                <c:pt idx="0">
                  <c:v>Psp onl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G$12:$I$12</c:f>
                <c:numCache>
                  <c:formatCode>General</c:formatCode>
                  <c:ptCount val="3"/>
                  <c:pt idx="0">
                    <c:v>0.43127758664599908</c:v>
                  </c:pt>
                  <c:pt idx="1">
                    <c:v>0.4012556997972983</c:v>
                  </c:pt>
                  <c:pt idx="2">
                    <c:v>0.53272792700925409</c:v>
                  </c:pt>
                </c:numCache>
              </c:numRef>
            </c:plus>
            <c:minus>
              <c:numRef>
                <c:f>Sheet5!$G$12:$I$12</c:f>
                <c:numCache>
                  <c:formatCode>General</c:formatCode>
                  <c:ptCount val="3"/>
                  <c:pt idx="0">
                    <c:v>0.43127758664599908</c:v>
                  </c:pt>
                  <c:pt idx="1">
                    <c:v>0.4012556997972983</c:v>
                  </c:pt>
                  <c:pt idx="2">
                    <c:v>0.532727927009254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B$11:$D$11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5!$B$12:$D$12</c:f>
              <c:numCache>
                <c:formatCode>General</c:formatCode>
                <c:ptCount val="3"/>
                <c:pt idx="0">
                  <c:v>2.4272909922371615</c:v>
                </c:pt>
                <c:pt idx="1">
                  <c:v>4.3066189726125863</c:v>
                </c:pt>
                <c:pt idx="2">
                  <c:v>5.8224100798312373</c:v>
                </c:pt>
              </c:numCache>
            </c:numRef>
          </c:val>
        </c:ser>
        <c:ser>
          <c:idx val="1"/>
          <c:order val="1"/>
          <c:tx>
            <c:strRef>
              <c:f>Sheet5!$A$13</c:f>
              <c:strCache>
                <c:ptCount val="1"/>
                <c:pt idx="0">
                  <c:v>FC-60 + Psp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G$13:$I$13</c:f>
                <c:numCache>
                  <c:formatCode>General</c:formatCode>
                  <c:ptCount val="3"/>
                  <c:pt idx="0">
                    <c:v>0.20478605194433822</c:v>
                  </c:pt>
                  <c:pt idx="1">
                    <c:v>0.20795078559638061</c:v>
                  </c:pt>
                  <c:pt idx="2">
                    <c:v>0.37985357226407174</c:v>
                  </c:pt>
                </c:numCache>
              </c:numRef>
            </c:plus>
            <c:minus>
              <c:numRef>
                <c:f>Sheet5!$G$13:$I$13</c:f>
                <c:numCache>
                  <c:formatCode>General</c:formatCode>
                  <c:ptCount val="3"/>
                  <c:pt idx="0">
                    <c:v>0.20478605194433822</c:v>
                  </c:pt>
                  <c:pt idx="1">
                    <c:v>0.20795078559638061</c:v>
                  </c:pt>
                  <c:pt idx="2">
                    <c:v>0.379853572264071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B$11:$D$11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5!$B$13:$D$13</c:f>
              <c:numCache>
                <c:formatCode>General</c:formatCode>
                <c:ptCount val="3"/>
                <c:pt idx="0">
                  <c:v>2.0383744202382315</c:v>
                </c:pt>
                <c:pt idx="1">
                  <c:v>4.9538188186110448</c:v>
                </c:pt>
                <c:pt idx="2">
                  <c:v>4.1717901826305894</c:v>
                </c:pt>
              </c:numCache>
            </c:numRef>
          </c:val>
        </c:ser>
        <c:ser>
          <c:idx val="2"/>
          <c:order val="2"/>
          <c:tx>
            <c:strRef>
              <c:f>Sheet5!$A$14</c:f>
              <c:strCache>
                <c:ptCount val="1"/>
                <c:pt idx="0">
                  <c:v>FC-40 + Ps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G$14:$I$14</c:f>
                <c:numCache>
                  <c:formatCode>General</c:formatCode>
                  <c:ptCount val="3"/>
                  <c:pt idx="0">
                    <c:v>0.47195053207603993</c:v>
                  </c:pt>
                  <c:pt idx="1">
                    <c:v>0.30816296797430015</c:v>
                  </c:pt>
                  <c:pt idx="2">
                    <c:v>0.1201006167325315</c:v>
                  </c:pt>
                </c:numCache>
              </c:numRef>
            </c:plus>
            <c:minus>
              <c:numRef>
                <c:f>Sheet5!$G$14:$I$14</c:f>
                <c:numCache>
                  <c:formatCode>General</c:formatCode>
                  <c:ptCount val="3"/>
                  <c:pt idx="0">
                    <c:v>0.47195053207603993</c:v>
                  </c:pt>
                  <c:pt idx="1">
                    <c:v>0.30816296797430015</c:v>
                  </c:pt>
                  <c:pt idx="2">
                    <c:v>0.12010061673253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B$11:$D$11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5!$B$14:$D$14</c:f>
              <c:numCache>
                <c:formatCode>General</c:formatCode>
                <c:ptCount val="3"/>
                <c:pt idx="0">
                  <c:v>2.0872500842870307</c:v>
                </c:pt>
                <c:pt idx="1">
                  <c:v>5.2178631848848553</c:v>
                </c:pt>
                <c:pt idx="2">
                  <c:v>4.2527756380192887</c:v>
                </c:pt>
              </c:numCache>
            </c:numRef>
          </c:val>
        </c:ser>
        <c:ser>
          <c:idx val="3"/>
          <c:order val="3"/>
          <c:tx>
            <c:strRef>
              <c:f>Sheet5!$A$15</c:f>
              <c:strCache>
                <c:ptCount val="1"/>
                <c:pt idx="0">
                  <c:v>FC-20 + Psp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G$15:$I$15</c:f>
                <c:numCache>
                  <c:formatCode>General</c:formatCode>
                  <c:ptCount val="3"/>
                  <c:pt idx="0">
                    <c:v>0.16043035598469044</c:v>
                  </c:pt>
                  <c:pt idx="1">
                    <c:v>0.16454784604540992</c:v>
                  </c:pt>
                  <c:pt idx="2">
                    <c:v>0.15413440327892336</c:v>
                  </c:pt>
                </c:numCache>
              </c:numRef>
            </c:plus>
            <c:minus>
              <c:numRef>
                <c:f>Sheet5!$G$15:$I$15</c:f>
                <c:numCache>
                  <c:formatCode>General</c:formatCode>
                  <c:ptCount val="3"/>
                  <c:pt idx="0">
                    <c:v>0.16043035598469044</c:v>
                  </c:pt>
                  <c:pt idx="1">
                    <c:v>0.16454784604540992</c:v>
                  </c:pt>
                  <c:pt idx="2">
                    <c:v>0.154134403278923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B$11:$D$11</c:f>
              <c:strCache>
                <c:ptCount val="3"/>
                <c:pt idx="0">
                  <c:v>0 DPT</c:v>
                </c:pt>
                <c:pt idx="1">
                  <c:v>2 DPT</c:v>
                </c:pt>
                <c:pt idx="2">
                  <c:v>6 DPT</c:v>
                </c:pt>
              </c:strCache>
            </c:strRef>
          </c:cat>
          <c:val>
            <c:numRef>
              <c:f>Sheet5!$B$15:$D$15</c:f>
              <c:numCache>
                <c:formatCode>General</c:formatCode>
                <c:ptCount val="3"/>
                <c:pt idx="0">
                  <c:v>2.1279456643766177</c:v>
                </c:pt>
                <c:pt idx="1">
                  <c:v>4.6794281838040037</c:v>
                </c:pt>
                <c:pt idx="2">
                  <c:v>4.64555123976524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48505120"/>
        <c:axId val="1048503488"/>
      </c:barChart>
      <c:catAx>
        <c:axId val="1048505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48503488"/>
        <c:crosses val="autoZero"/>
        <c:auto val="1"/>
        <c:lblAlgn val="ctr"/>
        <c:lblOffset val="100"/>
        <c:noMultiLvlLbl val="0"/>
      </c:catAx>
      <c:valAx>
        <c:axId val="1048503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 i="1" kern="1200" baseline="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n-planta</a:t>
                </a:r>
                <a:r>
                  <a:rPr lang="en-US" sz="900" b="1" i="0" kern="1200" baseline="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bacterial number </a:t>
                </a:r>
                <a:endParaRPr lang="en-US" sz="900" dirty="0" smtClean="0">
                  <a:effectLst/>
                </a:endParaRPr>
              </a:p>
              <a:p>
                <a:pPr>
                  <a:defRPr sz="900"/>
                </a:pPr>
                <a:r>
                  <a:rPr lang="en-US" sz="900" b="1" i="0" kern="1200" baseline="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  Log</a:t>
                </a:r>
                <a:r>
                  <a:rPr lang="en-US" sz="900" b="1" i="0" kern="1200" baseline="-2500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900" b="1" i="0" kern="1200" baseline="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(CFU /mg</a:t>
                </a:r>
                <a:r>
                  <a:rPr lang="en-US" sz="900" b="1" i="0" kern="1200" baseline="-2500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b="1" i="0" kern="1200" baseline="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) </a:t>
                </a:r>
                <a:endParaRPr lang="en-US" sz="9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48505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4721</cdr:x>
      <cdr:y>0.8777</cdr:y>
    </cdr:from>
    <cdr:to>
      <cdr:x>0.89703</cdr:x>
      <cdr:y>0.96929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430762" y="1958264"/>
          <a:ext cx="2194028" cy="2043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900" b="1" dirty="0" smtClean="0">
              <a:latin typeface="Arial" panose="020B0604020202020204" pitchFamily="34" charset="0"/>
              <a:cs typeface="Arial" panose="020B0604020202020204" pitchFamily="34" charset="0"/>
            </a:rPr>
            <a:t>Days post combined stress treatment</a:t>
          </a:r>
          <a:endParaRPr lang="en-US" sz="9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764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77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71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952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042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036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744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801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638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527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564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5DC6D-F6C1-4BC2-AD1F-6441E5BE089A}" type="datetimeFigureOut">
              <a:rPr lang="en-US" smtClean="0"/>
              <a:t>6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DACF3-4478-4B35-B461-F43DDC1E3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650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2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148962" y="176320"/>
            <a:ext cx="24144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497060" y="4183477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643481" y="3453110"/>
            <a:ext cx="6178637" cy="3390000"/>
            <a:chOff x="643481" y="3881121"/>
            <a:chExt cx="6178637" cy="3390000"/>
          </a:xfrm>
        </p:grpSpPr>
        <p:sp>
          <p:nvSpPr>
            <p:cNvPr id="11" name="TextBox 10"/>
            <p:cNvSpPr txBox="1"/>
            <p:nvPr/>
          </p:nvSpPr>
          <p:spPr>
            <a:xfrm>
              <a:off x="643481" y="3881121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654577" y="3918800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5" name="Group 74"/>
            <p:cNvGrpSpPr/>
            <p:nvPr/>
          </p:nvGrpSpPr>
          <p:grpSpPr>
            <a:xfrm>
              <a:off x="3896038" y="4300231"/>
              <a:ext cx="2926080" cy="2970890"/>
              <a:chOff x="3896038" y="4300231"/>
              <a:chExt cx="2926080" cy="2970890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84329249"/>
                  </p:ext>
                </p:extLst>
              </p:nvPr>
            </p:nvGraphicFramePr>
            <p:xfrm>
              <a:off x="3896038" y="4878145"/>
              <a:ext cx="2926080" cy="23929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21" name="Group 20"/>
              <p:cNvGrpSpPr/>
              <p:nvPr/>
            </p:nvGrpSpPr>
            <p:grpSpPr>
              <a:xfrm>
                <a:off x="5356666" y="4870439"/>
                <a:ext cx="1286669" cy="162812"/>
                <a:chOff x="4911865" y="1839545"/>
                <a:chExt cx="1286669" cy="96879"/>
              </a:xfrm>
            </p:grpSpPr>
            <p:cxnSp>
              <p:nvCxnSpPr>
                <p:cNvPr id="17" name="Straight Connector 16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>
                  <a:off x="6198534" y="183954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" name="Group 21"/>
              <p:cNvGrpSpPr/>
              <p:nvPr/>
            </p:nvGrpSpPr>
            <p:grpSpPr>
              <a:xfrm>
                <a:off x="5357881" y="4988570"/>
                <a:ext cx="681081" cy="223057"/>
                <a:chOff x="4911865" y="1843625"/>
                <a:chExt cx="1286634" cy="92799"/>
              </a:xfrm>
            </p:grpSpPr>
            <p:cxnSp>
              <p:nvCxnSpPr>
                <p:cNvPr id="23" name="Straight Connector 22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Connector 24"/>
                <p:cNvCxnSpPr/>
                <p:nvPr/>
              </p:nvCxnSpPr>
              <p:spPr>
                <a:xfrm>
                  <a:off x="6189057" y="184362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" name="Group 29"/>
              <p:cNvGrpSpPr/>
              <p:nvPr/>
            </p:nvGrpSpPr>
            <p:grpSpPr>
              <a:xfrm>
                <a:off x="4549579" y="5291911"/>
                <a:ext cx="197728" cy="115738"/>
                <a:chOff x="4911865" y="1843625"/>
                <a:chExt cx="1286634" cy="92799"/>
              </a:xfrm>
            </p:grpSpPr>
            <p:cxnSp>
              <p:nvCxnSpPr>
                <p:cNvPr id="31" name="Straight Connector 30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6189057" y="184362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" name="Group 41"/>
              <p:cNvGrpSpPr/>
              <p:nvPr/>
            </p:nvGrpSpPr>
            <p:grpSpPr>
              <a:xfrm>
                <a:off x="5158938" y="5492864"/>
                <a:ext cx="197728" cy="115738"/>
                <a:chOff x="4911865" y="1843625"/>
                <a:chExt cx="1286634" cy="92799"/>
              </a:xfrm>
            </p:grpSpPr>
            <p:cxnSp>
              <p:nvCxnSpPr>
                <p:cNvPr id="43" name="Straight Connector 42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6189057" y="184362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" name="Group 45"/>
              <p:cNvGrpSpPr/>
              <p:nvPr/>
            </p:nvGrpSpPr>
            <p:grpSpPr>
              <a:xfrm>
                <a:off x="6389173" y="5104142"/>
                <a:ext cx="197728" cy="115738"/>
                <a:chOff x="4911865" y="1843625"/>
                <a:chExt cx="1286634" cy="92799"/>
              </a:xfrm>
            </p:grpSpPr>
            <p:cxnSp>
              <p:nvCxnSpPr>
                <p:cNvPr id="47" name="Straight Connector 46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/>
                <p:cNvCxnSpPr/>
                <p:nvPr/>
              </p:nvCxnSpPr>
              <p:spPr>
                <a:xfrm>
                  <a:off x="6189057" y="184362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Group 49"/>
              <p:cNvGrpSpPr/>
              <p:nvPr/>
            </p:nvGrpSpPr>
            <p:grpSpPr>
              <a:xfrm>
                <a:off x="5158938" y="4745635"/>
                <a:ext cx="1484361" cy="249478"/>
                <a:chOff x="4911865" y="1842005"/>
                <a:chExt cx="1286634" cy="94419"/>
              </a:xfrm>
            </p:grpSpPr>
            <p:cxnSp>
              <p:nvCxnSpPr>
                <p:cNvPr id="51" name="Straight Connector 50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Connector 52"/>
                <p:cNvCxnSpPr/>
                <p:nvPr/>
              </p:nvCxnSpPr>
              <p:spPr>
                <a:xfrm>
                  <a:off x="6196905" y="184200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4" name="Group 53"/>
              <p:cNvGrpSpPr/>
              <p:nvPr/>
            </p:nvGrpSpPr>
            <p:grpSpPr>
              <a:xfrm>
                <a:off x="4745857" y="4469098"/>
                <a:ext cx="1288107" cy="196551"/>
                <a:chOff x="4911865" y="1840827"/>
                <a:chExt cx="1286634" cy="95597"/>
              </a:xfrm>
            </p:grpSpPr>
            <p:cxnSp>
              <p:nvCxnSpPr>
                <p:cNvPr id="55" name="Straight Connector 54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Connector 55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Straight Connector 56"/>
                <p:cNvCxnSpPr/>
                <p:nvPr/>
              </p:nvCxnSpPr>
              <p:spPr>
                <a:xfrm>
                  <a:off x="6189058" y="1840827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" name="Group 57"/>
              <p:cNvGrpSpPr/>
              <p:nvPr/>
            </p:nvGrpSpPr>
            <p:grpSpPr>
              <a:xfrm>
                <a:off x="4745857" y="4356464"/>
                <a:ext cx="1839593" cy="309200"/>
                <a:chOff x="4911865" y="1842334"/>
                <a:chExt cx="1286634" cy="94090"/>
              </a:xfrm>
            </p:grpSpPr>
            <p:cxnSp>
              <p:nvCxnSpPr>
                <p:cNvPr id="59" name="Straight Connector 58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Straight Connector 60"/>
                <p:cNvCxnSpPr/>
                <p:nvPr/>
              </p:nvCxnSpPr>
              <p:spPr>
                <a:xfrm>
                  <a:off x="6194718" y="184233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2" name="Group 61"/>
              <p:cNvGrpSpPr/>
              <p:nvPr/>
            </p:nvGrpSpPr>
            <p:grpSpPr>
              <a:xfrm>
                <a:off x="4744174" y="4639395"/>
                <a:ext cx="681082" cy="67607"/>
                <a:chOff x="4922727" y="1843625"/>
                <a:chExt cx="1286636" cy="92799"/>
              </a:xfrm>
            </p:grpSpPr>
            <p:cxnSp>
              <p:nvCxnSpPr>
                <p:cNvPr id="63" name="Straight Connector 62"/>
                <p:cNvCxnSpPr/>
                <p:nvPr/>
              </p:nvCxnSpPr>
              <p:spPr>
                <a:xfrm>
                  <a:off x="4922729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Straight Connector 63"/>
                <p:cNvCxnSpPr/>
                <p:nvPr/>
              </p:nvCxnSpPr>
              <p:spPr>
                <a:xfrm>
                  <a:off x="4922727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Straight Connector 64"/>
                <p:cNvCxnSpPr/>
                <p:nvPr/>
              </p:nvCxnSpPr>
              <p:spPr>
                <a:xfrm>
                  <a:off x="6197482" y="184362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6" name="TextBox 65"/>
              <p:cNvSpPr txBox="1"/>
              <p:nvPr/>
            </p:nvSpPr>
            <p:spPr>
              <a:xfrm>
                <a:off x="4509287" y="5110264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5134884" y="5311575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5558448" y="4818728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6361299" y="4932665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5880883" y="4698831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5723128" y="4554220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920378" y="4451708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5355902" y="4300231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9" name="Group 148"/>
            <p:cNvGrpSpPr/>
            <p:nvPr/>
          </p:nvGrpSpPr>
          <p:grpSpPr>
            <a:xfrm>
              <a:off x="783048" y="4183477"/>
              <a:ext cx="2926080" cy="2928145"/>
              <a:chOff x="783048" y="4183477"/>
              <a:chExt cx="2926080" cy="2928145"/>
            </a:xfrm>
          </p:grpSpPr>
          <p:sp>
            <p:nvSpPr>
              <p:cNvPr id="14" name="TextBox 1"/>
              <p:cNvSpPr txBox="1"/>
              <p:nvPr/>
            </p:nvSpPr>
            <p:spPr>
              <a:xfrm>
                <a:off x="1149074" y="6907278"/>
                <a:ext cx="2194028" cy="20434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s post combined stress treatment</a:t>
                </a:r>
                <a:endParaRPr 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48" name="Group 147"/>
              <p:cNvGrpSpPr/>
              <p:nvPr/>
            </p:nvGrpSpPr>
            <p:grpSpPr>
              <a:xfrm>
                <a:off x="783048" y="4183477"/>
                <a:ext cx="2926080" cy="2848501"/>
                <a:chOff x="783048" y="4183477"/>
                <a:chExt cx="2926080" cy="2848501"/>
              </a:xfrm>
            </p:grpSpPr>
            <p:graphicFrame>
              <p:nvGraphicFramePr>
                <p:cNvPr id="6" name="Chart 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2298612"/>
                    </p:ext>
                  </p:extLst>
                </p:nvPr>
              </p:nvGraphicFramePr>
              <p:xfrm>
                <a:off x="783048" y="4878144"/>
                <a:ext cx="2926080" cy="215383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pic>
              <p:nvPicPr>
                <p:cNvPr id="77" name="Picture 76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3048" t="1117" b="92495"/>
                <a:stretch/>
              </p:blipFill>
              <p:spPr>
                <a:xfrm>
                  <a:off x="1214318" y="4183477"/>
                  <a:ext cx="2200702" cy="118872"/>
                </a:xfrm>
                <a:prstGeom prst="rect">
                  <a:avLst/>
                </a:prstGeom>
              </p:spPr>
            </p:pic>
            <p:grpSp>
              <p:nvGrpSpPr>
                <p:cNvPr id="85" name="Group 84"/>
                <p:cNvGrpSpPr/>
                <p:nvPr/>
              </p:nvGrpSpPr>
              <p:grpSpPr>
                <a:xfrm>
                  <a:off x="1316116" y="5405953"/>
                  <a:ext cx="634065" cy="86911"/>
                  <a:chOff x="1316115" y="5237175"/>
                  <a:chExt cx="681081" cy="223057"/>
                </a:xfrm>
              </p:grpSpPr>
              <p:cxnSp>
                <p:nvCxnSpPr>
                  <p:cNvPr id="81" name="Straight Connector 80"/>
                  <p:cNvCxnSpPr/>
                  <p:nvPr/>
                </p:nvCxnSpPr>
                <p:spPr>
                  <a:xfrm>
                    <a:off x="1316115" y="5240442"/>
                    <a:ext cx="68108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2" name="Straight Connector 81"/>
                  <p:cNvCxnSpPr/>
                  <p:nvPr/>
                </p:nvCxnSpPr>
                <p:spPr>
                  <a:xfrm>
                    <a:off x="1316115" y="5240442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3" name="Straight Connector 82"/>
                  <p:cNvCxnSpPr/>
                  <p:nvPr/>
                </p:nvCxnSpPr>
                <p:spPr>
                  <a:xfrm>
                    <a:off x="1992198" y="5237175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6" name="Group 85"/>
                <p:cNvGrpSpPr/>
                <p:nvPr/>
              </p:nvGrpSpPr>
              <p:grpSpPr>
                <a:xfrm>
                  <a:off x="2146534" y="5203793"/>
                  <a:ext cx="634065" cy="86911"/>
                  <a:chOff x="1316115" y="5237175"/>
                  <a:chExt cx="681081" cy="223057"/>
                </a:xfrm>
              </p:grpSpPr>
              <p:cxnSp>
                <p:nvCxnSpPr>
                  <p:cNvPr id="87" name="Straight Connector 86"/>
                  <p:cNvCxnSpPr/>
                  <p:nvPr/>
                </p:nvCxnSpPr>
                <p:spPr>
                  <a:xfrm>
                    <a:off x="1316115" y="5240442"/>
                    <a:ext cx="68108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8" name="Straight Connector 87"/>
                  <p:cNvCxnSpPr/>
                  <p:nvPr/>
                </p:nvCxnSpPr>
                <p:spPr>
                  <a:xfrm>
                    <a:off x="1316115" y="5240442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9" name="Straight Connector 88"/>
                  <p:cNvCxnSpPr/>
                  <p:nvPr/>
                </p:nvCxnSpPr>
                <p:spPr>
                  <a:xfrm>
                    <a:off x="1992198" y="5237175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0" name="Group 89"/>
                <p:cNvGrpSpPr/>
                <p:nvPr/>
              </p:nvGrpSpPr>
              <p:grpSpPr>
                <a:xfrm>
                  <a:off x="2950129" y="4756585"/>
                  <a:ext cx="661350" cy="281984"/>
                  <a:chOff x="1316115" y="5239583"/>
                  <a:chExt cx="681081" cy="220649"/>
                </a:xfrm>
              </p:grpSpPr>
              <p:cxnSp>
                <p:nvCxnSpPr>
                  <p:cNvPr id="91" name="Straight Connector 90"/>
                  <p:cNvCxnSpPr/>
                  <p:nvPr/>
                </p:nvCxnSpPr>
                <p:spPr>
                  <a:xfrm>
                    <a:off x="1316115" y="5240442"/>
                    <a:ext cx="68108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" name="Straight Connector 91"/>
                  <p:cNvCxnSpPr/>
                  <p:nvPr/>
                </p:nvCxnSpPr>
                <p:spPr>
                  <a:xfrm>
                    <a:off x="1316115" y="5240442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Straight Connector 92"/>
                  <p:cNvCxnSpPr/>
                  <p:nvPr/>
                </p:nvCxnSpPr>
                <p:spPr>
                  <a:xfrm>
                    <a:off x="1995367" y="5239583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4" name="TextBox 93"/>
                <p:cNvSpPr txBox="1"/>
                <p:nvPr/>
              </p:nvSpPr>
              <p:spPr>
                <a:xfrm>
                  <a:off x="1835690" y="4790688"/>
                  <a:ext cx="2551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5" name="Group 94"/>
                <p:cNvGrpSpPr/>
                <p:nvPr/>
              </p:nvGrpSpPr>
              <p:grpSpPr>
                <a:xfrm>
                  <a:off x="3175346" y="5006608"/>
                  <a:ext cx="439571" cy="97534"/>
                  <a:chOff x="1316115" y="5237175"/>
                  <a:chExt cx="681081" cy="223057"/>
                </a:xfrm>
              </p:grpSpPr>
              <p:cxnSp>
                <p:nvCxnSpPr>
                  <p:cNvPr id="96" name="Straight Connector 95"/>
                  <p:cNvCxnSpPr/>
                  <p:nvPr/>
                </p:nvCxnSpPr>
                <p:spPr>
                  <a:xfrm>
                    <a:off x="1316115" y="5240442"/>
                    <a:ext cx="68108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Straight Connector 96"/>
                  <p:cNvCxnSpPr/>
                  <p:nvPr/>
                </p:nvCxnSpPr>
                <p:spPr>
                  <a:xfrm>
                    <a:off x="1316115" y="5240442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Straight Connector 97"/>
                  <p:cNvCxnSpPr/>
                  <p:nvPr/>
                </p:nvCxnSpPr>
                <p:spPr>
                  <a:xfrm>
                    <a:off x="1992198" y="5237175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9" name="Group 98"/>
                <p:cNvGrpSpPr/>
                <p:nvPr/>
              </p:nvGrpSpPr>
              <p:grpSpPr>
                <a:xfrm>
                  <a:off x="1600953" y="5004370"/>
                  <a:ext cx="885581" cy="199423"/>
                  <a:chOff x="1316115" y="5237175"/>
                  <a:chExt cx="681081" cy="223057"/>
                </a:xfrm>
              </p:grpSpPr>
              <p:cxnSp>
                <p:nvCxnSpPr>
                  <p:cNvPr id="100" name="Straight Connector 99"/>
                  <p:cNvCxnSpPr/>
                  <p:nvPr/>
                </p:nvCxnSpPr>
                <p:spPr>
                  <a:xfrm>
                    <a:off x="1316115" y="5240442"/>
                    <a:ext cx="68108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" name="Straight Connector 100"/>
                  <p:cNvCxnSpPr/>
                  <p:nvPr/>
                </p:nvCxnSpPr>
                <p:spPr>
                  <a:xfrm>
                    <a:off x="1316115" y="5240442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" name="Straight Connector 101"/>
                  <p:cNvCxnSpPr/>
                  <p:nvPr/>
                </p:nvCxnSpPr>
                <p:spPr>
                  <a:xfrm>
                    <a:off x="1992198" y="5237175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03" name="Group 102"/>
                <p:cNvGrpSpPr/>
                <p:nvPr/>
              </p:nvGrpSpPr>
              <p:grpSpPr>
                <a:xfrm>
                  <a:off x="2480035" y="4618972"/>
                  <a:ext cx="863067" cy="374689"/>
                  <a:chOff x="1316115" y="5237174"/>
                  <a:chExt cx="681081" cy="223058"/>
                </a:xfrm>
              </p:grpSpPr>
              <p:cxnSp>
                <p:nvCxnSpPr>
                  <p:cNvPr id="104" name="Straight Connector 103"/>
                  <p:cNvCxnSpPr/>
                  <p:nvPr/>
                </p:nvCxnSpPr>
                <p:spPr>
                  <a:xfrm>
                    <a:off x="1316115" y="5240442"/>
                    <a:ext cx="68108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Straight Connector 104"/>
                  <p:cNvCxnSpPr/>
                  <p:nvPr/>
                </p:nvCxnSpPr>
                <p:spPr>
                  <a:xfrm>
                    <a:off x="1316115" y="5240442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" name="Straight Connector 105"/>
                  <p:cNvCxnSpPr/>
                  <p:nvPr/>
                </p:nvCxnSpPr>
                <p:spPr>
                  <a:xfrm>
                    <a:off x="1996914" y="5237174"/>
                    <a:ext cx="0" cy="8165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7" name="TextBox 106"/>
                <p:cNvSpPr txBox="1"/>
                <p:nvPr/>
              </p:nvSpPr>
              <p:spPr>
                <a:xfrm>
                  <a:off x="2361610" y="4288627"/>
                  <a:ext cx="2551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08" name="Group 107"/>
                <p:cNvGrpSpPr/>
                <p:nvPr/>
              </p:nvGrpSpPr>
              <p:grpSpPr>
                <a:xfrm>
                  <a:off x="1612209" y="4481519"/>
                  <a:ext cx="1734422" cy="376711"/>
                  <a:chOff x="1316115" y="5240442"/>
                  <a:chExt cx="681081" cy="219790"/>
                </a:xfrm>
              </p:grpSpPr>
              <p:cxnSp>
                <p:nvCxnSpPr>
                  <p:cNvPr id="109" name="Straight Connector 108"/>
                  <p:cNvCxnSpPr/>
                  <p:nvPr/>
                </p:nvCxnSpPr>
                <p:spPr>
                  <a:xfrm>
                    <a:off x="1316115" y="5240442"/>
                    <a:ext cx="68108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" name="Straight Connector 109"/>
                  <p:cNvCxnSpPr/>
                  <p:nvPr/>
                </p:nvCxnSpPr>
                <p:spPr>
                  <a:xfrm>
                    <a:off x="1316115" y="5240442"/>
                    <a:ext cx="0" cy="21979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" name="Straight Connector 110"/>
                  <p:cNvCxnSpPr/>
                  <p:nvPr/>
                </p:nvCxnSpPr>
                <p:spPr>
                  <a:xfrm>
                    <a:off x="1995753" y="5242457"/>
                    <a:ext cx="0" cy="11858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2" name="TextBox 111"/>
                <p:cNvSpPr txBox="1"/>
                <p:nvPr/>
              </p:nvSpPr>
              <p:spPr>
                <a:xfrm>
                  <a:off x="2813414" y="4441027"/>
                  <a:ext cx="2551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3224349" y="4801575"/>
                  <a:ext cx="25519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2" name="Group 1"/>
          <p:cNvGrpSpPr/>
          <p:nvPr/>
        </p:nvGrpSpPr>
        <p:grpSpPr>
          <a:xfrm>
            <a:off x="647363" y="517031"/>
            <a:ext cx="5987845" cy="3084714"/>
            <a:chOff x="647363" y="867224"/>
            <a:chExt cx="5987845" cy="3084714"/>
          </a:xfrm>
        </p:grpSpPr>
        <p:sp>
          <p:nvSpPr>
            <p:cNvPr id="9" name="TextBox 8"/>
            <p:cNvSpPr txBox="1"/>
            <p:nvPr/>
          </p:nvSpPr>
          <p:spPr>
            <a:xfrm>
              <a:off x="647363" y="867224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54577" y="867707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0" name="Group 79"/>
            <p:cNvGrpSpPr/>
            <p:nvPr/>
          </p:nvGrpSpPr>
          <p:grpSpPr>
            <a:xfrm>
              <a:off x="3709128" y="1720802"/>
              <a:ext cx="2926080" cy="2231136"/>
              <a:chOff x="3709128" y="1720802"/>
              <a:chExt cx="2926080" cy="2231136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31762714"/>
                  </p:ext>
                </p:extLst>
              </p:nvPr>
            </p:nvGraphicFramePr>
            <p:xfrm>
              <a:off x="3709128" y="1720802"/>
              <a:ext cx="2926080" cy="22311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34" name="Group 33"/>
              <p:cNvGrpSpPr/>
              <p:nvPr/>
            </p:nvGrpSpPr>
            <p:grpSpPr>
              <a:xfrm>
                <a:off x="5599558" y="2055431"/>
                <a:ext cx="197728" cy="78794"/>
                <a:chOff x="4911865" y="1843625"/>
                <a:chExt cx="1286634" cy="92799"/>
              </a:xfrm>
            </p:grpSpPr>
            <p:cxnSp>
              <p:nvCxnSpPr>
                <p:cNvPr id="35" name="Straight Connector 34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36"/>
                <p:cNvCxnSpPr/>
                <p:nvPr/>
              </p:nvCxnSpPr>
              <p:spPr>
                <a:xfrm>
                  <a:off x="6189057" y="184362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" name="Group 37"/>
              <p:cNvGrpSpPr/>
              <p:nvPr/>
            </p:nvGrpSpPr>
            <p:grpSpPr>
              <a:xfrm>
                <a:off x="6201454" y="1941766"/>
                <a:ext cx="197728" cy="75932"/>
                <a:chOff x="4911865" y="1843625"/>
                <a:chExt cx="1286634" cy="92799"/>
              </a:xfrm>
            </p:grpSpPr>
            <p:cxnSp>
              <p:nvCxnSpPr>
                <p:cNvPr id="39" name="Straight Connector 38"/>
                <p:cNvCxnSpPr/>
                <p:nvPr/>
              </p:nvCxnSpPr>
              <p:spPr>
                <a:xfrm>
                  <a:off x="4911865" y="1844984"/>
                  <a:ext cx="128663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/>
                <p:cNvCxnSpPr/>
                <p:nvPr/>
              </p:nvCxnSpPr>
              <p:spPr>
                <a:xfrm>
                  <a:off x="4911865" y="184498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/>
                <p:cNvCxnSpPr/>
                <p:nvPr/>
              </p:nvCxnSpPr>
              <p:spPr>
                <a:xfrm>
                  <a:off x="6189057" y="1843625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8" name="TextBox 77"/>
              <p:cNvSpPr txBox="1"/>
              <p:nvPr/>
            </p:nvSpPr>
            <p:spPr>
              <a:xfrm>
                <a:off x="5566422" y="1862697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6166957" y="1747654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7" name="Group 146"/>
            <p:cNvGrpSpPr/>
            <p:nvPr/>
          </p:nvGrpSpPr>
          <p:grpSpPr>
            <a:xfrm>
              <a:off x="783048" y="1398996"/>
              <a:ext cx="2926080" cy="2552942"/>
              <a:chOff x="783048" y="1398996"/>
              <a:chExt cx="2926080" cy="2552942"/>
            </a:xfrm>
          </p:grpSpPr>
          <p:graphicFrame>
            <p:nvGraphicFramePr>
              <p:cNvPr id="7" name="Chart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12962168"/>
                  </p:ext>
                </p:extLst>
              </p:nvPr>
            </p:nvGraphicFramePr>
            <p:xfrm>
              <a:off x="783048" y="1720802"/>
              <a:ext cx="2926080" cy="22311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pSp>
            <p:nvGrpSpPr>
              <p:cNvPr id="115" name="Group 114"/>
              <p:cNvGrpSpPr/>
              <p:nvPr/>
            </p:nvGrpSpPr>
            <p:grpSpPr>
              <a:xfrm>
                <a:off x="1363157" y="2530378"/>
                <a:ext cx="634065" cy="86911"/>
                <a:chOff x="1316115" y="5237175"/>
                <a:chExt cx="681081" cy="223057"/>
              </a:xfrm>
            </p:grpSpPr>
            <p:cxnSp>
              <p:nvCxnSpPr>
                <p:cNvPr id="116" name="Straight Connector 115"/>
                <p:cNvCxnSpPr/>
                <p:nvPr/>
              </p:nvCxnSpPr>
              <p:spPr>
                <a:xfrm>
                  <a:off x="1316115" y="5240442"/>
                  <a:ext cx="68108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Straight Connector 116"/>
                <p:cNvCxnSpPr/>
                <p:nvPr/>
              </p:nvCxnSpPr>
              <p:spPr>
                <a:xfrm>
                  <a:off x="1316115" y="5240442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8" name="Straight Connector 117"/>
                <p:cNvCxnSpPr/>
                <p:nvPr/>
              </p:nvCxnSpPr>
              <p:spPr>
                <a:xfrm>
                  <a:off x="1992198" y="5237175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9" name="Group 118"/>
              <p:cNvGrpSpPr/>
              <p:nvPr/>
            </p:nvGrpSpPr>
            <p:grpSpPr>
              <a:xfrm>
                <a:off x="2111162" y="2053446"/>
                <a:ext cx="634065" cy="86911"/>
                <a:chOff x="1316115" y="5237175"/>
                <a:chExt cx="681081" cy="223057"/>
              </a:xfrm>
            </p:grpSpPr>
            <p:cxnSp>
              <p:nvCxnSpPr>
                <p:cNvPr id="120" name="Straight Connector 119"/>
                <p:cNvCxnSpPr/>
                <p:nvPr/>
              </p:nvCxnSpPr>
              <p:spPr>
                <a:xfrm>
                  <a:off x="1316115" y="5240442"/>
                  <a:ext cx="68108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Straight Connector 120"/>
                <p:cNvCxnSpPr/>
                <p:nvPr/>
              </p:nvCxnSpPr>
              <p:spPr>
                <a:xfrm>
                  <a:off x="1316115" y="5240442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Connector 121"/>
                <p:cNvCxnSpPr/>
                <p:nvPr/>
              </p:nvCxnSpPr>
              <p:spPr>
                <a:xfrm>
                  <a:off x="1992198" y="5237175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3" name="Group 122"/>
              <p:cNvGrpSpPr/>
              <p:nvPr/>
            </p:nvGrpSpPr>
            <p:grpSpPr>
              <a:xfrm>
                <a:off x="2985133" y="1855178"/>
                <a:ext cx="103717" cy="86588"/>
                <a:chOff x="1316115" y="5237175"/>
                <a:chExt cx="681081" cy="223057"/>
              </a:xfrm>
            </p:grpSpPr>
            <p:cxnSp>
              <p:nvCxnSpPr>
                <p:cNvPr id="124" name="Straight Connector 123"/>
                <p:cNvCxnSpPr/>
                <p:nvPr/>
              </p:nvCxnSpPr>
              <p:spPr>
                <a:xfrm>
                  <a:off x="1316115" y="5240442"/>
                  <a:ext cx="68108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1316115" y="5240442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Straight Connector 125"/>
                <p:cNvCxnSpPr/>
                <p:nvPr/>
              </p:nvCxnSpPr>
              <p:spPr>
                <a:xfrm>
                  <a:off x="1992198" y="5237175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7" name="Group 126"/>
              <p:cNvGrpSpPr/>
              <p:nvPr/>
            </p:nvGrpSpPr>
            <p:grpSpPr>
              <a:xfrm>
                <a:off x="1655615" y="1917255"/>
                <a:ext cx="705995" cy="92769"/>
                <a:chOff x="1316115" y="5237175"/>
                <a:chExt cx="681081" cy="223057"/>
              </a:xfrm>
            </p:grpSpPr>
            <p:cxnSp>
              <p:nvCxnSpPr>
                <p:cNvPr id="128" name="Straight Connector 127"/>
                <p:cNvCxnSpPr/>
                <p:nvPr/>
              </p:nvCxnSpPr>
              <p:spPr>
                <a:xfrm>
                  <a:off x="1316115" y="5240442"/>
                  <a:ext cx="68108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Straight Connector 128"/>
                <p:cNvCxnSpPr/>
                <p:nvPr/>
              </p:nvCxnSpPr>
              <p:spPr>
                <a:xfrm>
                  <a:off x="1316115" y="5240442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Straight Connector 129"/>
                <p:cNvCxnSpPr/>
                <p:nvPr/>
              </p:nvCxnSpPr>
              <p:spPr>
                <a:xfrm>
                  <a:off x="1992198" y="5237175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5" name="Group 134"/>
              <p:cNvGrpSpPr/>
              <p:nvPr/>
            </p:nvGrpSpPr>
            <p:grpSpPr>
              <a:xfrm>
                <a:off x="1659250" y="1600333"/>
                <a:ext cx="1734422" cy="262364"/>
                <a:chOff x="1316115" y="5237175"/>
                <a:chExt cx="681081" cy="223057"/>
              </a:xfrm>
            </p:grpSpPr>
            <p:cxnSp>
              <p:nvCxnSpPr>
                <p:cNvPr id="136" name="Straight Connector 135"/>
                <p:cNvCxnSpPr/>
                <p:nvPr/>
              </p:nvCxnSpPr>
              <p:spPr>
                <a:xfrm>
                  <a:off x="1316115" y="5240442"/>
                  <a:ext cx="68108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Straight Connector 136"/>
                <p:cNvCxnSpPr/>
                <p:nvPr/>
              </p:nvCxnSpPr>
              <p:spPr>
                <a:xfrm>
                  <a:off x="1316115" y="5240442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Straight Connector 137"/>
                <p:cNvCxnSpPr/>
                <p:nvPr/>
              </p:nvCxnSpPr>
              <p:spPr>
                <a:xfrm>
                  <a:off x="1995376" y="5237175"/>
                  <a:ext cx="0" cy="11858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9" name="TextBox 138"/>
              <p:cNvSpPr txBox="1"/>
              <p:nvPr/>
            </p:nvSpPr>
            <p:spPr>
              <a:xfrm>
                <a:off x="1871656" y="1723915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40" name="Group 139"/>
              <p:cNvGrpSpPr/>
              <p:nvPr/>
            </p:nvGrpSpPr>
            <p:grpSpPr>
              <a:xfrm>
                <a:off x="2985133" y="1739905"/>
                <a:ext cx="286257" cy="140437"/>
                <a:chOff x="1316115" y="5237175"/>
                <a:chExt cx="681081" cy="223057"/>
              </a:xfrm>
            </p:grpSpPr>
            <p:cxnSp>
              <p:nvCxnSpPr>
                <p:cNvPr id="141" name="Straight Connector 140"/>
                <p:cNvCxnSpPr/>
                <p:nvPr/>
              </p:nvCxnSpPr>
              <p:spPr>
                <a:xfrm>
                  <a:off x="1316115" y="5240442"/>
                  <a:ext cx="68108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Straight Connector 141"/>
                <p:cNvCxnSpPr/>
                <p:nvPr/>
              </p:nvCxnSpPr>
              <p:spPr>
                <a:xfrm>
                  <a:off x="1316115" y="5240442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Straight Connector 142"/>
                <p:cNvCxnSpPr/>
                <p:nvPr/>
              </p:nvCxnSpPr>
              <p:spPr>
                <a:xfrm>
                  <a:off x="1992198" y="5237175"/>
                  <a:ext cx="0" cy="2197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4" name="TextBox 143"/>
              <p:cNvSpPr txBox="1"/>
              <p:nvPr/>
            </p:nvSpPr>
            <p:spPr>
              <a:xfrm>
                <a:off x="2430150" y="1398996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2915953" y="167544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2974777" y="1564826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50" name="Picture 149"/>
          <p:cNvPicPr>
            <a:picLocks noChangeAspect="1"/>
          </p:cNvPicPr>
          <p:nvPr/>
        </p:nvPicPr>
        <p:blipFill rotWithShape="1">
          <a:blip r:embed="rId7"/>
          <a:srcRect l="5184" t="85332" b="5642"/>
          <a:stretch/>
        </p:blipFill>
        <p:spPr>
          <a:xfrm>
            <a:off x="1265139" y="878768"/>
            <a:ext cx="2324021" cy="1828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0" y="6998459"/>
            <a:ext cx="682211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Assessment of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planta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cterial number and total chlorophyll content based on leaf dry weight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-plant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cterial numbers Log</a:t>
            </a:r>
            <a:r>
              <a:rPr lang="en-US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FU/mg fres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were converted into Log10 CFU/mg dr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o avoid discrepancy caused by drought induced reduction in fresh weight. The correct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actor fro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ll the treatments; pathogen only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ly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ly)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Ps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FC-60 +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o FC-20 +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DRs (FC-60 +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o FC-20 +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was calculated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 arrive at correct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actor fresh weight and dry weight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 m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ameter punches (3 biological replicate and 2 technical replicate of each) were taken from each and was expressed as ratio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dr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o fres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. The bacterial number Log10 (CFU/mg dr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= bacteria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 Log10 (CFU/mg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res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x correction factor was calculated. Bacteria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 Log10 (CFU/mg dr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for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Ps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DRs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presented in the form of bar diagram. Total chlorophyll content was also calculated based on dr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the 4 mm diameter leaf punches. Total chlorophyll content for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Ps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DRs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shown here. Graph A) and B) is average of 9 replicate and graph B) and C) is average of 6 replicates. Statistical significance was checked by two way ANOVA and significant difference at p&lt;0.05 was shown as * and at p&lt;0.02 as **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details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see Figure 2 and Figure 3.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39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9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9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15242FC0-8433-4B4C-8EFE-DDA3B750C669}"/>
</file>

<file path=customXml/itemProps2.xml><?xml version="1.0" encoding="utf-8"?>
<ds:datastoreItem xmlns:ds="http://schemas.openxmlformats.org/officeDocument/2006/customXml" ds:itemID="{157FED92-F7BE-4514-8D7E-0C883D814452}"/>
</file>

<file path=customXml/itemProps3.xml><?xml version="1.0" encoding="utf-8"?>
<ds:datastoreItem xmlns:ds="http://schemas.openxmlformats.org/officeDocument/2006/customXml" ds:itemID="{CC781F56-8F74-4BE4-8029-D25CE71A8734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2</TotalTime>
  <Words>345</Words>
  <Application>Microsoft Office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njita Sinha</dc:creator>
  <cp:lastModifiedBy>Senthil-Kumar Muthappa</cp:lastModifiedBy>
  <cp:revision>33</cp:revision>
  <dcterms:created xsi:type="dcterms:W3CDTF">2016-06-01T06:17:41Z</dcterms:created>
  <dcterms:modified xsi:type="dcterms:W3CDTF">2016-06-02T10:55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